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9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11.png" ContentType="image/png"/>
  <Override PartName="/ppt/media/image12.jpeg" ContentType="image/jpeg"/>
  <Override PartName="/ppt/media/image8.jpeg" ContentType="image/jpeg"/>
  <Override PartName="/ppt/media/image13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6858000" cy="9144000"/>
          </a:xfrm>
          <a:custGeom>
            <a:avLst/>
            <a:gdLst>
              <a:gd name="textAreaLeft" fmla="*/ 360 w 6858000"/>
              <a:gd name="textAreaRight" fmla="*/ 6857640 w 6858000"/>
              <a:gd name="textAreaTop" fmla="*/ 360 h 9144000"/>
              <a:gd name="textAreaBottom" fmla="*/ 9143640 h 9144000"/>
            </a:gdLst>
            <a:ahLst/>
            <a:rect l="textAreaLeft" t="textAreaTop" r="textAreaRight" b="textAreaBottom"/>
            <a:pathLst>
              <a:path w="21600" h="28800">
                <a:moveTo>
                  <a:pt x="5" y="0"/>
                </a:moveTo>
                <a:arcTo wR="5" hR="5" stAng="16200000" swAng="-5400000"/>
                <a:lnTo>
                  <a:pt x="0" y="28795"/>
                </a:lnTo>
                <a:arcTo wR="5" hR="5" stAng="10800000" swAng="-5400000"/>
                <a:lnTo>
                  <a:pt x="21595" y="28800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2971800" cy="46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884760" y="0"/>
            <a:ext cx="2971800" cy="46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0560" cy="3427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49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0" y="8683560"/>
            <a:ext cx="2971800" cy="46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sldNum" idx="2"/>
          </p:nvPr>
        </p:nvSpPr>
        <p:spPr>
          <a:xfrm>
            <a:off x="3884760" y="8685000"/>
            <a:ext cx="2970000" cy="45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859CBEA7-0DC6-4724-B8AA-768C93FB9E32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6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95DA3E57-366A-4832-A4F1-C6954EA0ED7A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EA7B4187-41D4-4E84-A6EE-544321CAFC26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1143000" y="68580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1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6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07582B6-E246-4C51-BCD4-E1C9C97C2A40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4EB463A-64E6-45E5-AF69-A4C03946A646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953ECD4-56D1-41FE-9B20-FBCCF44B20B3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C7A6922-184C-438E-BDDD-47AB845427FB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AAEDD05-8E5E-40D6-8CAA-65FD02F432E2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E6DFAB4-65F0-4DE5-844E-8A65115579D7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2A029FE-5449-4A1D-A1F7-FC23E75D08C9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3A4B018-023E-491B-B055-5543DF52EE92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B900C3E-667C-4898-8AF2-B7525D072F06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7D53588-A03B-4993-A979-BCD8E5651F4B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DCADF0B-2B99-4058-9BC9-C4F48B773B7D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3000"/>
              </a:lnSpc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AAEFDF4-34E1-4C98-949F-70FED552DD0D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1280" indent="-34128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1240" indent="-28404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3000"/>
              </a:lnSpc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45720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245280"/>
            <a:ext cx="289584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6552720" y="6245280"/>
            <a:ext cx="21322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37B8B70D-228F-4660-A62F-C929D15D227D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png"/><Relationship Id="rId12" Type="http://schemas.openxmlformats.org/officeDocument/2006/relationships/image" Target="../media/image9.jpeg"/><Relationship Id="rId13" Type="http://schemas.openxmlformats.org/officeDocument/2006/relationships/image" Target="../media/image10.jpeg"/><Relationship Id="rId14" Type="http://schemas.openxmlformats.org/officeDocument/2006/relationships/image" Target="../media/image6.jpeg"/><Relationship Id="rId15" Type="http://schemas.openxmlformats.org/officeDocument/2006/relationships/image" Target="../media/image8.jpeg"/><Relationship Id="rId16" Type="http://schemas.openxmlformats.org/officeDocument/2006/relationships/image" Target="../media/image12.jpeg"/><Relationship Id="rId17" Type="http://schemas.openxmlformats.org/officeDocument/2006/relationships/image" Target="../media/image13.jpeg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6286680" y="111240"/>
            <a:ext cx="2782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Tomimaru Y, et al.</a:t>
            </a: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>
            <a:lum contrast="-40000"/>
          </a:blip>
          <a:srcRect l="0" t="28180" r="1677" b="16908"/>
          <a:stretch/>
        </p:blipFill>
        <p:spPr>
          <a:xfrm>
            <a:off x="1104840" y="3645000"/>
            <a:ext cx="2610000" cy="56520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2"/>
          <a:srcRect l="4003" t="26407" r="2002" b="31272"/>
          <a:stretch/>
        </p:blipFill>
        <p:spPr>
          <a:xfrm>
            <a:off x="1104840" y="4241880"/>
            <a:ext cx="2610000" cy="56520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3"/>
          <a:srcRect l="1643" t="20071" r="1233" b="20071"/>
          <a:stretch/>
        </p:blipFill>
        <p:spPr>
          <a:xfrm>
            <a:off x="1104840" y="6033960"/>
            <a:ext cx="2610000" cy="56376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127080" y="3743280"/>
            <a:ext cx="98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pSTAT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314720" y="2708280"/>
            <a:ext cx="84204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LC-P/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792880" y="2708280"/>
            <a:ext cx="57996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LC-P/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73240" y="6132600"/>
            <a:ext cx="68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22280" y="3311640"/>
            <a:ext cx="702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IFN-</a:t>
            </a:r>
            <a:r>
              <a:rPr b="0" lang="en-GB" sz="16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265400" y="3176640"/>
            <a:ext cx="9410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-     +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104840" y="3282840"/>
            <a:ext cx="126360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611440" y="3176640"/>
            <a:ext cx="9410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-     +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451240" y="3282840"/>
            <a:ext cx="126360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84320" y="4340160"/>
            <a:ext cx="86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STAT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14200" y="326880"/>
            <a:ext cx="2203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000680" y="326880"/>
            <a:ext cx="2034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" descr=""/>
          <p:cNvPicPr/>
          <p:nvPr/>
        </p:nvPicPr>
        <p:blipFill>
          <a:blip r:embed="rId4"/>
          <a:srcRect l="784" t="8968" r="784" b="5922"/>
          <a:stretch/>
        </p:blipFill>
        <p:spPr>
          <a:xfrm>
            <a:off x="1387440" y="1011240"/>
            <a:ext cx="1889280" cy="75420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5">
            <a:lum bright="-6000"/>
          </a:blip>
          <a:srcRect l="2274" t="7994" r="2274" b="20060"/>
          <a:stretch/>
        </p:blipFill>
        <p:spPr>
          <a:xfrm>
            <a:off x="1378080" y="1884240"/>
            <a:ext cx="1888920" cy="714600"/>
          </a:xfrm>
          <a:prstGeom prst="rect">
            <a:avLst/>
          </a:prstGeom>
          <a:ln w="0">
            <a:noFill/>
          </a:ln>
        </p:spPr>
      </p:pic>
      <p:sp>
        <p:nvSpPr>
          <p:cNvPr id="67" name=""/>
          <p:cNvSpPr/>
          <p:nvPr/>
        </p:nvSpPr>
        <p:spPr>
          <a:xfrm>
            <a:off x="396720" y="1204920"/>
            <a:ext cx="97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IFNAR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438560" y="476280"/>
            <a:ext cx="84204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LC-P/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500560" y="476280"/>
            <a:ext cx="57996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LC-P/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41800" y="2058840"/>
            <a:ext cx="68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Act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037400" y="1535040"/>
            <a:ext cx="726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p-Ty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(IRS-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110480" y="4210200"/>
            <a:ext cx="57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858200" y="785880"/>
            <a:ext cx="7200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PLC-P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970960" y="785880"/>
            <a:ext cx="4960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PLC-P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hRN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130640" y="1241280"/>
            <a:ext cx="71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Ins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978440" y="1190520"/>
            <a:ext cx="66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-      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757760" y="1235160"/>
            <a:ext cx="9190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872320" y="1190520"/>
            <a:ext cx="66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-      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5757840" y="1235160"/>
            <a:ext cx="9190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096080" y="2286000"/>
            <a:ext cx="607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IRS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7152120" y="785880"/>
            <a:ext cx="7200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PLC-P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8264880" y="785880"/>
            <a:ext cx="49608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PLC-P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shRN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129560" y="2965320"/>
            <a:ext cx="53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p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176720" y="3618000"/>
            <a:ext cx="44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Ak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424560" y="1241280"/>
            <a:ext cx="71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IGF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7186680" y="1190520"/>
            <a:ext cx="66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-      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7051680" y="1235160"/>
            <a:ext cx="9190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8047080" y="1190520"/>
            <a:ext cx="66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-      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8053560" y="1235160"/>
            <a:ext cx="91728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27080" y="4937040"/>
            <a:ext cx="98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pSTAT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84320" y="5533920"/>
            <a:ext cx="86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ゴシック"/>
              </a:rPr>
              <a:t>STAT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H="1" rot="16200000">
            <a:off x="3468960" y="1365120"/>
            <a:ext cx="100080" cy="198360"/>
          </a:xfrm>
          <a:prstGeom prst="flowChartExtract">
            <a:avLst/>
          </a:prstGeom>
          <a:solidFill>
            <a:srgbClr val="000000"/>
          </a:solidFill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" descr=""/>
          <p:cNvPicPr/>
          <p:nvPr/>
        </p:nvPicPr>
        <p:blipFill>
          <a:blip r:embed="rId6"/>
          <a:srcRect l="1524" t="0" r="51362" b="0"/>
          <a:stretch/>
        </p:blipFill>
        <p:spPr>
          <a:xfrm>
            <a:off x="4743360" y="4132440"/>
            <a:ext cx="1933560" cy="47448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7">
            <a:lum contrast="-10000"/>
          </a:blip>
          <a:srcRect l="4260" t="25974" r="0" b="8658"/>
          <a:stretch/>
        </p:blipFill>
        <p:spPr>
          <a:xfrm>
            <a:off x="7051680" y="1541520"/>
            <a:ext cx="1933560" cy="474480"/>
          </a:xfrm>
          <a:prstGeom prst="rect">
            <a:avLst/>
          </a:prstGeom>
          <a:ln w="0">
            <a:noFill/>
          </a:ln>
        </p:spPr>
      </p:pic>
      <p:pic>
        <p:nvPicPr>
          <p:cNvPr id="95" name="" descr=""/>
          <p:cNvPicPr/>
          <p:nvPr/>
        </p:nvPicPr>
        <p:blipFill>
          <a:blip r:embed="rId8"/>
          <a:srcRect l="50732" t="0" r="2660" b="0"/>
          <a:stretch/>
        </p:blipFill>
        <p:spPr>
          <a:xfrm>
            <a:off x="7051680" y="3486240"/>
            <a:ext cx="1933560" cy="47304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9"/>
          <a:srcRect l="1011" t="10448" r="49131" b="0"/>
          <a:stretch/>
        </p:blipFill>
        <p:spPr>
          <a:xfrm>
            <a:off x="4745160" y="2190600"/>
            <a:ext cx="1931760" cy="474840"/>
          </a:xfrm>
          <a:prstGeom prst="rect">
            <a:avLst/>
          </a:prstGeom>
          <a:ln w="0">
            <a:noFill/>
          </a:ln>
        </p:spPr>
      </p:pic>
      <p:pic>
        <p:nvPicPr>
          <p:cNvPr id="97" name="" descr=""/>
          <p:cNvPicPr/>
          <p:nvPr/>
        </p:nvPicPr>
        <p:blipFill>
          <a:blip r:embed="rId10"/>
          <a:srcRect l="1958" t="0" r="49726" b="0"/>
          <a:stretch/>
        </p:blipFill>
        <p:spPr>
          <a:xfrm>
            <a:off x="4743360" y="2836800"/>
            <a:ext cx="1933560" cy="476280"/>
          </a:xfrm>
          <a:prstGeom prst="rect">
            <a:avLst/>
          </a:prstGeom>
          <a:ln w="0">
            <a:noFill/>
          </a:ln>
        </p:spPr>
      </p:pic>
      <p:pic>
        <p:nvPicPr>
          <p:cNvPr id="98" name="" descr=""/>
          <p:cNvPicPr/>
          <p:nvPr/>
        </p:nvPicPr>
        <p:blipFill>
          <a:blip r:embed="rId11"/>
          <a:stretch/>
        </p:blipFill>
        <p:spPr>
          <a:xfrm>
            <a:off x="4741920" y="1541520"/>
            <a:ext cx="1935000" cy="476280"/>
          </a:xfrm>
          <a:prstGeom prst="rect">
            <a:avLst/>
          </a:prstGeom>
          <a:ln w="0">
            <a:noFill/>
          </a:ln>
        </p:spPr>
      </p:pic>
      <p:pic>
        <p:nvPicPr>
          <p:cNvPr id="99" name="" descr=""/>
          <p:cNvPicPr/>
          <p:nvPr/>
        </p:nvPicPr>
        <p:blipFill>
          <a:blip r:embed="rId12"/>
          <a:srcRect l="50182" t="2985" r="0" b="6567"/>
          <a:stretch/>
        </p:blipFill>
        <p:spPr>
          <a:xfrm>
            <a:off x="7051680" y="2189160"/>
            <a:ext cx="1932120" cy="474840"/>
          </a:xfrm>
          <a:prstGeom prst="rect">
            <a:avLst/>
          </a:prstGeom>
          <a:ln w="0">
            <a:noFill/>
          </a:ln>
        </p:spPr>
      </p:pic>
      <p:pic>
        <p:nvPicPr>
          <p:cNvPr id="100" name="" descr=""/>
          <p:cNvPicPr/>
          <p:nvPr/>
        </p:nvPicPr>
        <p:blipFill>
          <a:blip r:embed="rId13"/>
          <a:srcRect l="50509" t="0" r="1175" b="0"/>
          <a:stretch/>
        </p:blipFill>
        <p:spPr>
          <a:xfrm>
            <a:off x="7051680" y="2838600"/>
            <a:ext cx="1933560" cy="474480"/>
          </a:xfrm>
          <a:prstGeom prst="rect">
            <a:avLst/>
          </a:prstGeom>
          <a:ln w="0">
            <a:noFill/>
          </a:ln>
        </p:spPr>
      </p:pic>
      <p:pic>
        <p:nvPicPr>
          <p:cNvPr id="101" name="" descr=""/>
          <p:cNvPicPr/>
          <p:nvPr/>
        </p:nvPicPr>
        <p:blipFill>
          <a:blip r:embed="rId14"/>
          <a:srcRect l="48771" t="0" r="3810" b="0"/>
          <a:stretch/>
        </p:blipFill>
        <p:spPr>
          <a:xfrm>
            <a:off x="7051680" y="4132440"/>
            <a:ext cx="1933560" cy="474480"/>
          </a:xfrm>
          <a:prstGeom prst="rect">
            <a:avLst/>
          </a:prstGeom>
          <a:ln w="0">
            <a:noFill/>
          </a:ln>
        </p:spPr>
      </p:pic>
      <p:pic>
        <p:nvPicPr>
          <p:cNvPr id="102" name="" descr=""/>
          <p:cNvPicPr/>
          <p:nvPr/>
        </p:nvPicPr>
        <p:blipFill>
          <a:blip r:embed="rId15"/>
          <a:srcRect l="3040" t="0" r="49781" b="0"/>
          <a:stretch/>
        </p:blipFill>
        <p:spPr>
          <a:xfrm>
            <a:off x="4743360" y="3484440"/>
            <a:ext cx="1933560" cy="476280"/>
          </a:xfrm>
          <a:prstGeom prst="rect">
            <a:avLst/>
          </a:prstGeom>
          <a:ln w="0">
            <a:noFill/>
          </a:ln>
        </p:spPr>
      </p:pic>
      <p:pic>
        <p:nvPicPr>
          <p:cNvPr id="103" name="" descr=""/>
          <p:cNvPicPr/>
          <p:nvPr/>
        </p:nvPicPr>
        <p:blipFill>
          <a:blip r:embed="rId16"/>
          <a:stretch/>
        </p:blipFill>
        <p:spPr>
          <a:xfrm>
            <a:off x="1104840" y="5437080"/>
            <a:ext cx="2610000" cy="565200"/>
          </a:xfrm>
          <a:prstGeom prst="rect">
            <a:avLst/>
          </a:prstGeom>
          <a:ln w="0">
            <a:noFill/>
          </a:ln>
        </p:spPr>
      </p:pic>
      <p:pic>
        <p:nvPicPr>
          <p:cNvPr id="104" name="" descr=""/>
          <p:cNvPicPr/>
          <p:nvPr/>
        </p:nvPicPr>
        <p:blipFill>
          <a:blip r:embed="rId17"/>
          <a:srcRect l="0" t="3883" r="17241" b="0"/>
          <a:stretch/>
        </p:blipFill>
        <p:spPr>
          <a:xfrm>
            <a:off x="1104840" y="4838760"/>
            <a:ext cx="2610000" cy="566640"/>
          </a:xfrm>
          <a:prstGeom prst="rect">
            <a:avLst/>
          </a:prstGeom>
          <a:ln w="0">
            <a:noFill/>
          </a:ln>
        </p:spPr>
      </p:pic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"/>
          <p:cNvSpPr/>
          <p:nvPr/>
        </p:nvSpPr>
        <p:spPr>
          <a:xfrm flipH="1" rot="16200000">
            <a:off x="-441000" y="1677240"/>
            <a:ext cx="1454400" cy="42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GB" sz="1400" spc="-1" strike="noStrike">
                <a:solidFill>
                  <a:srgbClr val="000000"/>
                </a:solidFill>
                <a:latin typeface="Times New Roman"/>
              </a:rPr>
              <a:t>IGFBP7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relativ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expression (/</a:t>
            </a:r>
            <a:r>
              <a:rPr b="0" i="1" lang="en-GB" sz="1400" spc="-1" strike="noStrike">
                <a:solidFill>
                  <a:srgbClr val="000000"/>
                </a:solidFill>
                <a:latin typeface="Times New Roman"/>
              </a:rPr>
              <a:t>GBPD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38640" y="2871720"/>
            <a:ext cx="2246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389600" y="2940120"/>
            <a:ext cx="842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554560" y="2940120"/>
            <a:ext cx="53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4016880" y="2940120"/>
            <a:ext cx="842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181840" y="2940120"/>
            <a:ext cx="53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6623280" y="2940120"/>
            <a:ext cx="842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7788600" y="2940120"/>
            <a:ext cx="53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3" name=""/>
          <p:cNvGrpSpPr/>
          <p:nvPr/>
        </p:nvGrpSpPr>
        <p:grpSpPr>
          <a:xfrm>
            <a:off x="1297080" y="3179880"/>
            <a:ext cx="7213680" cy="248400"/>
            <a:chOff x="1297080" y="3179880"/>
            <a:chExt cx="7213680" cy="248400"/>
          </a:xfrm>
        </p:grpSpPr>
        <p:sp>
          <p:nvSpPr>
            <p:cNvPr id="114" name=""/>
            <p:cNvSpPr/>
            <p:nvPr/>
          </p:nvSpPr>
          <p:spPr>
            <a:xfrm>
              <a:off x="2038320" y="3214800"/>
              <a:ext cx="485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PLC-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297080" y="3179880"/>
              <a:ext cx="1979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732560" y="3214800"/>
              <a:ext cx="345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HL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924360" y="3179880"/>
              <a:ext cx="1979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7261200" y="3214800"/>
              <a:ext cx="506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Hep3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6531120" y="3179880"/>
              <a:ext cx="19796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0" name=""/>
          <p:cNvGrpSpPr/>
          <p:nvPr/>
        </p:nvGrpSpPr>
        <p:grpSpPr>
          <a:xfrm>
            <a:off x="638640" y="785880"/>
            <a:ext cx="8218080" cy="2131920"/>
            <a:chOff x="638640" y="785880"/>
            <a:chExt cx="8218080" cy="2131920"/>
          </a:xfrm>
        </p:grpSpPr>
        <p:sp>
          <p:nvSpPr>
            <p:cNvPr id="121" name=""/>
            <p:cNvSpPr/>
            <p:nvPr/>
          </p:nvSpPr>
          <p:spPr>
            <a:xfrm>
              <a:off x="638640" y="2471760"/>
              <a:ext cx="224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0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638640" y="1665360"/>
              <a:ext cx="224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1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638640" y="861840"/>
              <a:ext cx="224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2.5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638640" y="1263600"/>
              <a:ext cx="224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2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V="1">
              <a:off x="1039680" y="785880"/>
              <a:ext cx="3240" cy="2131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958680" y="927000"/>
              <a:ext cx="8424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958680" y="2516040"/>
              <a:ext cx="8424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958680" y="2119320"/>
              <a:ext cx="8424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958680" y="1324080"/>
              <a:ext cx="8424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958680" y="1720800"/>
              <a:ext cx="8424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638640" y="2068560"/>
              <a:ext cx="224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1.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V="1">
              <a:off x="1824120" y="2133360"/>
              <a:ext cx="1440" cy="9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1636560" y="2133720"/>
              <a:ext cx="37476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flipV="1">
              <a:off x="2779560" y="2725560"/>
              <a:ext cx="3240" cy="446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593800" y="2728800"/>
              <a:ext cx="37476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024440" y="2825640"/>
              <a:ext cx="841320" cy="8280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0" bIns="360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6645240" y="1231920"/>
              <a:ext cx="841320" cy="168444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444920" y="2739960"/>
              <a:ext cx="1800" cy="82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4257720" y="2739960"/>
              <a:ext cx="37476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979880" y="2871720"/>
              <a:ext cx="841320" cy="36720"/>
            </a:xfrm>
            <a:prstGeom prst="rect">
              <a:avLst/>
            </a:prstGeom>
            <a:solidFill>
              <a:srgbClr val="40404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080" bIns="-1008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V="1">
              <a:off x="5398920" y="2860560"/>
              <a:ext cx="1800" cy="129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5213520" y="2862360"/>
              <a:ext cx="37440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V="1">
              <a:off x="7064280" y="960120"/>
              <a:ext cx="1800" cy="2667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6878520" y="960480"/>
              <a:ext cx="37476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7607160" y="2575080"/>
              <a:ext cx="841680" cy="341280"/>
            </a:xfrm>
            <a:prstGeom prst="rect">
              <a:avLst/>
            </a:prstGeom>
            <a:solidFill>
              <a:srgbClr val="40404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flipV="1">
              <a:off x="8026560" y="2549160"/>
              <a:ext cx="1440" cy="270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7840800" y="2548080"/>
              <a:ext cx="37440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403280" y="2224080"/>
              <a:ext cx="841320" cy="69228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360520" y="2768760"/>
              <a:ext cx="841320" cy="147600"/>
            </a:xfrm>
            <a:prstGeom prst="rect">
              <a:avLst/>
            </a:prstGeom>
            <a:solidFill>
              <a:srgbClr val="40404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5076720" y="2489040"/>
              <a:ext cx="74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(48%)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7721640" y="2197080"/>
              <a:ext cx="671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(20%)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454120" y="2400480"/>
              <a:ext cx="749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(21%)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042920" y="2913120"/>
              <a:ext cx="781380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4" name=""/>
          <p:cNvGrpSpPr/>
          <p:nvPr/>
        </p:nvGrpSpPr>
        <p:grpSpPr>
          <a:xfrm>
            <a:off x="2360520" y="4454640"/>
            <a:ext cx="841320" cy="1577880"/>
            <a:chOff x="2360520" y="4454640"/>
            <a:chExt cx="841320" cy="1577880"/>
          </a:xfrm>
        </p:grpSpPr>
        <p:sp>
          <p:nvSpPr>
            <p:cNvPr id="155" name=""/>
            <p:cNvSpPr/>
            <p:nvPr/>
          </p:nvSpPr>
          <p:spPr>
            <a:xfrm>
              <a:off x="2360520" y="4556160"/>
              <a:ext cx="841320" cy="1476360"/>
            </a:xfrm>
            <a:prstGeom prst="rect">
              <a:avLst/>
            </a:prstGeom>
            <a:solidFill>
              <a:srgbClr val="40404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2779560" y="4454640"/>
              <a:ext cx="1800" cy="1029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593800" y="4456080"/>
              <a:ext cx="37476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8" name=""/>
          <p:cNvSpPr/>
          <p:nvPr/>
        </p:nvSpPr>
        <p:spPr>
          <a:xfrm>
            <a:off x="771480" y="598500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592560" y="4084560"/>
            <a:ext cx="270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flipV="1">
            <a:off x="1039680" y="3803760"/>
            <a:ext cx="3240" cy="22320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958680" y="5094360"/>
            <a:ext cx="8424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958680" y="4159080"/>
            <a:ext cx="8424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682560" y="501984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4" name=""/>
          <p:cNvGrpSpPr/>
          <p:nvPr/>
        </p:nvGrpSpPr>
        <p:grpSpPr>
          <a:xfrm>
            <a:off x="1825560" y="3643200"/>
            <a:ext cx="6202440" cy="213480"/>
            <a:chOff x="1825560" y="3643200"/>
            <a:chExt cx="6202440" cy="213480"/>
          </a:xfrm>
        </p:grpSpPr>
        <p:grpSp>
          <p:nvGrpSpPr>
            <p:cNvPr id="165" name=""/>
            <p:cNvGrpSpPr/>
            <p:nvPr/>
          </p:nvGrpSpPr>
          <p:grpSpPr>
            <a:xfrm>
              <a:off x="1825560" y="3643200"/>
              <a:ext cx="960480" cy="213480"/>
              <a:chOff x="1825560" y="3643200"/>
              <a:chExt cx="960480" cy="213480"/>
            </a:xfrm>
          </p:grpSpPr>
          <p:sp>
            <p:nvSpPr>
              <p:cNvPr id="166" name=""/>
              <p:cNvSpPr/>
              <p:nvPr/>
            </p:nvSpPr>
            <p:spPr>
              <a:xfrm flipV="1" rot="16200000">
                <a:off x="2286000" y="3311640"/>
                <a:ext cx="39600" cy="96048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360 h 960480"/>
                  <a:gd name="textAreaBottom" fmla="*/ 961200 h 9604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0"/>
                      <a:pt x="21600" y="0"/>
                    </a:cubicBezTo>
                    <a:lnTo>
                      <a:pt x="21600" y="21600"/>
                    </a:lnTo>
                    <a:cubicBezTo>
                      <a:pt x="21600" y="21600"/>
                      <a:pt x="108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2257560" y="364320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lang="en-GB" sz="14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8" name=""/>
            <p:cNvGrpSpPr/>
            <p:nvPr/>
          </p:nvGrpSpPr>
          <p:grpSpPr>
            <a:xfrm>
              <a:off x="7067520" y="3643200"/>
              <a:ext cx="960480" cy="213480"/>
              <a:chOff x="7067520" y="3643200"/>
              <a:chExt cx="960480" cy="213480"/>
            </a:xfrm>
          </p:grpSpPr>
          <p:sp>
            <p:nvSpPr>
              <p:cNvPr id="169" name=""/>
              <p:cNvSpPr/>
              <p:nvPr/>
            </p:nvSpPr>
            <p:spPr>
              <a:xfrm flipV="1" rot="16200000">
                <a:off x="7527960" y="3311640"/>
                <a:ext cx="39600" cy="96048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360 h 960480"/>
                  <a:gd name="textAreaBottom" fmla="*/ 961200 h 9604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0"/>
                      <a:pt x="21600" y="0"/>
                    </a:cubicBezTo>
                    <a:lnTo>
                      <a:pt x="21600" y="21600"/>
                    </a:lnTo>
                    <a:cubicBezTo>
                      <a:pt x="21600" y="21600"/>
                      <a:pt x="108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7499520" y="364320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lang="en-GB" sz="14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1" name=""/>
            <p:cNvGrpSpPr/>
            <p:nvPr/>
          </p:nvGrpSpPr>
          <p:grpSpPr>
            <a:xfrm>
              <a:off x="4446720" y="3643200"/>
              <a:ext cx="960480" cy="213480"/>
              <a:chOff x="4446720" y="3643200"/>
              <a:chExt cx="960480" cy="213480"/>
            </a:xfrm>
          </p:grpSpPr>
          <p:sp>
            <p:nvSpPr>
              <p:cNvPr id="172" name=""/>
              <p:cNvSpPr/>
              <p:nvPr/>
            </p:nvSpPr>
            <p:spPr>
              <a:xfrm flipV="1" rot="16200000">
                <a:off x="4907160" y="3311640"/>
                <a:ext cx="39600" cy="96048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360 h 960480"/>
                  <a:gd name="textAreaBottom" fmla="*/ 961200 h 9604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0"/>
                      <a:pt x="21600" y="0"/>
                    </a:cubicBezTo>
                    <a:lnTo>
                      <a:pt x="21600" y="21600"/>
                    </a:lnTo>
                    <a:cubicBezTo>
                      <a:pt x="21600" y="21600"/>
                      <a:pt x="108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4878360" y="364320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lang="en-GB" sz="14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74" name=""/>
          <p:cNvSpPr/>
          <p:nvPr/>
        </p:nvSpPr>
        <p:spPr>
          <a:xfrm>
            <a:off x="1389600" y="6058080"/>
            <a:ext cx="842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554560" y="6058080"/>
            <a:ext cx="53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4016880" y="6058080"/>
            <a:ext cx="842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5181840" y="6058080"/>
            <a:ext cx="53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6623280" y="6058080"/>
            <a:ext cx="842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-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7788600" y="6058080"/>
            <a:ext cx="53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0" name=""/>
          <p:cNvGrpSpPr/>
          <p:nvPr/>
        </p:nvGrpSpPr>
        <p:grpSpPr>
          <a:xfrm>
            <a:off x="7607160" y="4389480"/>
            <a:ext cx="841680" cy="1643040"/>
            <a:chOff x="7607160" y="4389480"/>
            <a:chExt cx="841680" cy="1643040"/>
          </a:xfrm>
        </p:grpSpPr>
        <p:sp>
          <p:nvSpPr>
            <p:cNvPr id="181" name=""/>
            <p:cNvSpPr/>
            <p:nvPr/>
          </p:nvSpPr>
          <p:spPr>
            <a:xfrm>
              <a:off x="7607160" y="4483080"/>
              <a:ext cx="841680" cy="1549440"/>
            </a:xfrm>
            <a:prstGeom prst="rect">
              <a:avLst/>
            </a:prstGeom>
            <a:solidFill>
              <a:srgbClr val="40404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flipV="1">
              <a:off x="8026560" y="4389480"/>
              <a:ext cx="1440" cy="950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7840800" y="4390920"/>
              <a:ext cx="37440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4" name=""/>
          <p:cNvGrpSpPr/>
          <p:nvPr/>
        </p:nvGrpSpPr>
        <p:grpSpPr>
          <a:xfrm>
            <a:off x="4979880" y="4086000"/>
            <a:ext cx="841320" cy="1946520"/>
            <a:chOff x="4979880" y="4086000"/>
            <a:chExt cx="841320" cy="1946520"/>
          </a:xfrm>
        </p:grpSpPr>
        <p:sp>
          <p:nvSpPr>
            <p:cNvPr id="185" name=""/>
            <p:cNvSpPr/>
            <p:nvPr/>
          </p:nvSpPr>
          <p:spPr>
            <a:xfrm flipV="1">
              <a:off x="5398920" y="4086000"/>
              <a:ext cx="3240" cy="1587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5213520" y="4089240"/>
              <a:ext cx="374400" cy="18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979880" y="4246560"/>
              <a:ext cx="841320" cy="1785960"/>
            </a:xfrm>
            <a:prstGeom prst="rect">
              <a:avLst/>
            </a:prstGeom>
            <a:solidFill>
              <a:srgbClr val="40404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8" name=""/>
          <p:cNvSpPr/>
          <p:nvPr/>
        </p:nvSpPr>
        <p:spPr>
          <a:xfrm flipV="1">
            <a:off x="4443480" y="4268520"/>
            <a:ext cx="1440" cy="889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4257720" y="4270320"/>
            <a:ext cx="37476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4024440" y="4356000"/>
            <a:ext cx="841320" cy="1676520"/>
          </a:xfrm>
          <a:prstGeom prst="rect">
            <a:avLst/>
          </a:prstGeom>
          <a:solidFill>
            <a:srgbClr val="d9d9d9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rot="16200000">
            <a:off x="-233280" y="4767480"/>
            <a:ext cx="1254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Cell viability (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2" name=""/>
          <p:cNvGrpSpPr/>
          <p:nvPr/>
        </p:nvGrpSpPr>
        <p:grpSpPr>
          <a:xfrm>
            <a:off x="6645240" y="4741560"/>
            <a:ext cx="841320" cy="1290960"/>
            <a:chOff x="6645240" y="4741560"/>
            <a:chExt cx="841320" cy="1290960"/>
          </a:xfrm>
        </p:grpSpPr>
        <p:sp>
          <p:nvSpPr>
            <p:cNvPr id="193" name=""/>
            <p:cNvSpPr/>
            <p:nvPr/>
          </p:nvSpPr>
          <p:spPr>
            <a:xfrm flipV="1">
              <a:off x="7064280" y="4741560"/>
              <a:ext cx="1800" cy="680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6878520" y="4745160"/>
              <a:ext cx="37476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6645240" y="4784760"/>
              <a:ext cx="841320" cy="124776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6" name=""/>
          <p:cNvGrpSpPr/>
          <p:nvPr/>
        </p:nvGrpSpPr>
        <p:grpSpPr>
          <a:xfrm>
            <a:off x="1403280" y="4851000"/>
            <a:ext cx="841320" cy="1181520"/>
            <a:chOff x="1403280" y="4851000"/>
            <a:chExt cx="841320" cy="1181520"/>
          </a:xfrm>
        </p:grpSpPr>
        <p:sp>
          <p:nvSpPr>
            <p:cNvPr id="197" name=""/>
            <p:cNvSpPr/>
            <p:nvPr/>
          </p:nvSpPr>
          <p:spPr>
            <a:xfrm flipV="1">
              <a:off x="1822320" y="4851000"/>
              <a:ext cx="1800" cy="5868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1636560" y="4853160"/>
              <a:ext cx="37476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1403280" y="4881600"/>
              <a:ext cx="841320" cy="1150920"/>
            </a:xfrm>
            <a:prstGeom prst="rect">
              <a:avLst/>
            </a:prstGeom>
            <a:solidFill>
              <a:srgbClr val="d9d9d9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0" name=""/>
          <p:cNvSpPr/>
          <p:nvPr/>
        </p:nvSpPr>
        <p:spPr>
          <a:xfrm>
            <a:off x="1042920" y="6031080"/>
            <a:ext cx="781380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1" name=""/>
          <p:cNvGrpSpPr/>
          <p:nvPr/>
        </p:nvGrpSpPr>
        <p:grpSpPr>
          <a:xfrm>
            <a:off x="1297080" y="6292800"/>
            <a:ext cx="7213680" cy="248400"/>
            <a:chOff x="1297080" y="6292800"/>
            <a:chExt cx="7213680" cy="248400"/>
          </a:xfrm>
        </p:grpSpPr>
        <p:sp>
          <p:nvSpPr>
            <p:cNvPr id="202" name=""/>
            <p:cNvSpPr/>
            <p:nvPr/>
          </p:nvSpPr>
          <p:spPr>
            <a:xfrm>
              <a:off x="2038320" y="6327720"/>
              <a:ext cx="485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PLC-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1297080" y="6292800"/>
              <a:ext cx="19796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4732560" y="6327720"/>
              <a:ext cx="3452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HL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3924360" y="6292800"/>
              <a:ext cx="19796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7261200" y="6327720"/>
              <a:ext cx="506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Times New Roman"/>
                </a:rPr>
                <a:t>Hep3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6531120" y="6292800"/>
              <a:ext cx="19796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8" name=""/>
          <p:cNvGrpSpPr/>
          <p:nvPr/>
        </p:nvGrpSpPr>
        <p:grpSpPr>
          <a:xfrm>
            <a:off x="1825560" y="642960"/>
            <a:ext cx="6202440" cy="213480"/>
            <a:chOff x="1825560" y="642960"/>
            <a:chExt cx="6202440" cy="213480"/>
          </a:xfrm>
        </p:grpSpPr>
        <p:grpSp>
          <p:nvGrpSpPr>
            <p:cNvPr id="209" name=""/>
            <p:cNvGrpSpPr/>
            <p:nvPr/>
          </p:nvGrpSpPr>
          <p:grpSpPr>
            <a:xfrm>
              <a:off x="1825560" y="642960"/>
              <a:ext cx="960480" cy="213480"/>
              <a:chOff x="1825560" y="642960"/>
              <a:chExt cx="960480" cy="213480"/>
            </a:xfrm>
          </p:grpSpPr>
          <p:sp>
            <p:nvSpPr>
              <p:cNvPr id="210" name=""/>
              <p:cNvSpPr/>
              <p:nvPr/>
            </p:nvSpPr>
            <p:spPr>
              <a:xfrm flipV="1" rot="16200000">
                <a:off x="2286000" y="311040"/>
                <a:ext cx="39600" cy="96048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360 h 960480"/>
                  <a:gd name="textAreaBottom" fmla="*/ 961200 h 9604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0"/>
                      <a:pt x="21600" y="0"/>
                    </a:cubicBezTo>
                    <a:lnTo>
                      <a:pt x="21600" y="21600"/>
                    </a:lnTo>
                    <a:cubicBezTo>
                      <a:pt x="21600" y="21600"/>
                      <a:pt x="108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2257560" y="6429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lang="en-GB" sz="14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2" name=""/>
            <p:cNvGrpSpPr/>
            <p:nvPr/>
          </p:nvGrpSpPr>
          <p:grpSpPr>
            <a:xfrm>
              <a:off x="7067520" y="642960"/>
              <a:ext cx="960480" cy="213480"/>
              <a:chOff x="7067520" y="642960"/>
              <a:chExt cx="960480" cy="213480"/>
            </a:xfrm>
          </p:grpSpPr>
          <p:sp>
            <p:nvSpPr>
              <p:cNvPr id="213" name=""/>
              <p:cNvSpPr/>
              <p:nvPr/>
            </p:nvSpPr>
            <p:spPr>
              <a:xfrm flipV="1" rot="16200000">
                <a:off x="7527960" y="311040"/>
                <a:ext cx="39600" cy="96048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360 h 960480"/>
                  <a:gd name="textAreaBottom" fmla="*/ 961200 h 9604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0"/>
                      <a:pt x="21600" y="0"/>
                    </a:cubicBezTo>
                    <a:lnTo>
                      <a:pt x="21600" y="21600"/>
                    </a:lnTo>
                    <a:cubicBezTo>
                      <a:pt x="21600" y="21600"/>
                      <a:pt x="108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7499520" y="6429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lang="en-GB" sz="14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5" name=""/>
            <p:cNvGrpSpPr/>
            <p:nvPr/>
          </p:nvGrpSpPr>
          <p:grpSpPr>
            <a:xfrm>
              <a:off x="4446720" y="642960"/>
              <a:ext cx="960480" cy="213480"/>
              <a:chOff x="4446720" y="642960"/>
              <a:chExt cx="960480" cy="213480"/>
            </a:xfrm>
          </p:grpSpPr>
          <p:sp>
            <p:nvSpPr>
              <p:cNvPr id="216" name=""/>
              <p:cNvSpPr/>
              <p:nvPr/>
            </p:nvSpPr>
            <p:spPr>
              <a:xfrm flipV="1" rot="16200000">
                <a:off x="4907160" y="311040"/>
                <a:ext cx="39600" cy="960480"/>
              </a:xfrm>
              <a:custGeom>
                <a:avLst/>
                <a:gdLst>
                  <a:gd name="textAreaLeft" fmla="*/ 0 w 39600"/>
                  <a:gd name="textAreaRight" fmla="*/ 27720 w 39600"/>
                  <a:gd name="textAreaTop" fmla="*/ 360 h 960480"/>
                  <a:gd name="textAreaBottom" fmla="*/ 961200 h 9604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10800" y="0"/>
                      <a:pt x="21600" y="0"/>
                      <a:pt x="21600" y="0"/>
                    </a:cubicBezTo>
                    <a:lnTo>
                      <a:pt x="21600" y="21600"/>
                    </a:lnTo>
                    <a:cubicBezTo>
                      <a:pt x="21600" y="21600"/>
                      <a:pt x="10800" y="21600"/>
                      <a:pt x="0" y="21600"/>
                    </a:cubicBezTo>
                  </a:path>
                </a:pathLst>
              </a:cu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lnSpc>
                    <a:spcPct val="93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4878360" y="6429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0" lang="en-GB" sz="1400" spc="-1" strike="noStrike">
                    <a:solidFill>
                      <a:srgbClr val="000000"/>
                    </a:solidFill>
                    <a:latin typeface="Times New Roman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18" name=""/>
          <p:cNvSpPr/>
          <p:nvPr/>
        </p:nvSpPr>
        <p:spPr>
          <a:xfrm>
            <a:off x="208080" y="272880"/>
            <a:ext cx="22032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206280" y="3357720"/>
            <a:ext cx="2034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6286680" y="111240"/>
            <a:ext cx="2782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Tomimaru Y, et al.</a:t>
            </a: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Figure S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Yoshito TOMIMARU</dc:creator>
  <dc:description/>
  <dc:language>en-US</dc:language>
  <cp:lastModifiedBy>Yoshito TOMIMARU</cp:lastModifiedBy>
  <cp:revision>0</cp:revision>
  <dc:subject/>
  <dc:title>Research Progress</dc:title>
</cp:coreProperties>
</file>